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</p:sldIdLst>
  <p:sldSz cx="6858000" cy="795496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588"/>
    <p:restoredTop sz="94634"/>
  </p:normalViewPr>
  <p:slideViewPr>
    <p:cSldViewPr snapToGrid="0" snapToObjects="1">
      <p:cViewPr varScale="1">
        <p:scale>
          <a:sx n="148" d="100"/>
          <a:sy n="148" d="100"/>
        </p:scale>
        <p:origin x="167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301889"/>
            <a:ext cx="5829300" cy="276950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178198"/>
            <a:ext cx="5143500" cy="192060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86B0F-7F55-A54F-B541-1AC2A8667775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CD663-8C59-C144-8551-A5DE0C55FFB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86B0F-7F55-A54F-B541-1AC2A8667775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CD663-8C59-C144-8551-A5DE0C55FFB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23528"/>
            <a:ext cx="1478756" cy="674146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23528"/>
            <a:ext cx="4350544" cy="674146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86B0F-7F55-A54F-B541-1AC2A8667775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CD663-8C59-C144-8551-A5DE0C55FFB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86B0F-7F55-A54F-B541-1AC2A8667775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CD663-8C59-C144-8551-A5DE0C55FFB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1983219"/>
            <a:ext cx="5915025" cy="3309043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5323566"/>
            <a:ext cx="5915025" cy="1740148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86B0F-7F55-A54F-B541-1AC2A8667775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CD663-8C59-C144-8551-A5DE0C55FFB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117641"/>
            <a:ext cx="2914650" cy="504735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117641"/>
            <a:ext cx="2914650" cy="504735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86B0F-7F55-A54F-B541-1AC2A8667775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CD663-8C59-C144-8551-A5DE0C55FFB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23530"/>
            <a:ext cx="5915025" cy="153759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1950071"/>
            <a:ext cx="2901255" cy="955700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2905771"/>
            <a:ext cx="2901255" cy="427395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1950071"/>
            <a:ext cx="2915543" cy="955700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2905771"/>
            <a:ext cx="2915543" cy="427395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86B0F-7F55-A54F-B541-1AC2A8667775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CD663-8C59-C144-8551-A5DE0C55FFB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86B0F-7F55-A54F-B541-1AC2A8667775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CD663-8C59-C144-8551-A5DE0C55FFB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86B0F-7F55-A54F-B541-1AC2A8667775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CD663-8C59-C144-8551-A5DE0C55FFB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30331"/>
            <a:ext cx="2211884" cy="1856158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145369"/>
            <a:ext cx="3471863" cy="565318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386489"/>
            <a:ext cx="2211884" cy="442126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86B0F-7F55-A54F-B541-1AC2A8667775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CD663-8C59-C144-8551-A5DE0C55FFB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30331"/>
            <a:ext cx="2211884" cy="1856158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145369"/>
            <a:ext cx="3471863" cy="5653180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386489"/>
            <a:ext cx="2211884" cy="442126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86B0F-7F55-A54F-B541-1AC2A8667775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DCD663-8C59-C144-8551-A5DE0C55FFB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23530"/>
            <a:ext cx="5915025" cy="15375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117641"/>
            <a:ext cx="5915025" cy="504735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7373074"/>
            <a:ext cx="1543050" cy="42352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D86B0F-7F55-A54F-B541-1AC2A8667775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7373074"/>
            <a:ext cx="2314575" cy="42352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7373074"/>
            <a:ext cx="1543050" cy="42352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DCD663-8C59-C144-8551-A5DE0C55FF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16427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1562418" y="3215204"/>
            <a:ext cx="3190297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75" dirty="0"/>
              <a:t>TSS-2kb                     TSS      TSS+1kb                              TES-1kb      TES                     TES+2kb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50946" y="2299937"/>
            <a:ext cx="144643" cy="246428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4712768" y="2235798"/>
            <a:ext cx="7024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M</a:t>
            </a:r>
            <a:r>
              <a:rPr lang="en-US" sz="900" dirty="0"/>
              <a:t>ed17 </a:t>
            </a:r>
            <a:r>
              <a:rPr lang="en-US" sz="900" dirty="0"/>
              <a:t>WT</a:t>
            </a:r>
          </a:p>
          <a:p>
            <a:r>
              <a:rPr lang="en-US" sz="900" dirty="0"/>
              <a:t>Pol II WT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62418" y="1908062"/>
            <a:ext cx="2941071" cy="1307143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51703" y="3512392"/>
            <a:ext cx="2951786" cy="1317857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1562418" y="4800067"/>
            <a:ext cx="3190297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75" dirty="0"/>
              <a:t>TSS-2kb                     TSS      TSS+1kb                              TES-1kb      TES                     TES+2kb</a:t>
            </a:r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00996" y="3970825"/>
            <a:ext cx="133928" cy="235715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4650945" y="3906433"/>
            <a:ext cx="16385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M</a:t>
            </a:r>
            <a:r>
              <a:rPr lang="en-US" sz="900" dirty="0"/>
              <a:t>ed17 </a:t>
            </a:r>
            <a:r>
              <a:rPr lang="en-US" sz="900" i="1" dirty="0"/>
              <a:t>med2∆ med3∆ med15∆</a:t>
            </a:r>
          </a:p>
          <a:p>
            <a:r>
              <a:rPr lang="en-US" sz="900" dirty="0"/>
              <a:t>Pol II </a:t>
            </a:r>
            <a:r>
              <a:rPr lang="en-US" sz="900" i="1" dirty="0"/>
              <a:t>med3∆ med15∆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739154" y="1223615"/>
            <a:ext cx="3669639" cy="4619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20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verage </a:t>
            </a:r>
            <a:r>
              <a:rPr lang="en-US" sz="120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l II and Med17 (head module) occupancy in wild type and tail module deletion mutants</a:t>
            </a:r>
            <a:endParaRPr lang="en-US" sz="1201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824753" y="6795248"/>
            <a:ext cx="1676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4 Figur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449139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0</Words>
  <Application>Microsoft Macintosh PowerPoint</Application>
  <PresentationFormat>Custom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41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rse, Randall H (HEALTH)</dc:creator>
  <cp:lastModifiedBy>Morse, Randall H (HEALTH)</cp:lastModifiedBy>
  <cp:revision>1</cp:revision>
  <dcterms:created xsi:type="dcterms:W3CDTF">2017-12-18T19:37:28Z</dcterms:created>
  <dcterms:modified xsi:type="dcterms:W3CDTF">2017-12-18T19:37:57Z</dcterms:modified>
</cp:coreProperties>
</file>